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6" r:id="rId4"/>
    <p:sldId id="260" r:id="rId5"/>
    <p:sldId id="25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498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623340-4E49-4099-3E8D-DC0BB5C96E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15619A7-A342-12D2-1EB8-A9E6D62B34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B2C1AA-E64D-9C2C-D47C-EA989E57D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1C3CE8-275D-1074-6933-06B9F1668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1102EF-4C81-9F7C-BE5C-D86551E1D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3846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E52E24-C325-9F2A-6F19-98169898FD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B77110-D7F8-A3FB-8123-38B8CE6CAF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CEE154-920A-670F-DE8F-823F93423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C921AA-FE8F-8744-BFE3-0E64ABF23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E0D8ED-DF72-B05D-9333-731999CB6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7444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147A6B7-DE08-87F4-FE03-23A2F6E2F7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2DCBCD2-F6AE-7239-44D9-1050CAD893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C9BCEE-0E0B-98D0-9F68-852A210DA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ADD87C-D72C-7352-836A-B5E27C68E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282F84-7D8F-07FA-87C4-C8C416977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535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7B2815-EB2B-0116-EDB0-CBA26F2AE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AB60DE-8882-1B5C-971A-39BCE58AA4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AD7CF3-FA79-1361-A3FC-E255AB31A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5F366A-4075-4E0A-3991-9F9816FE0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44A564-D591-1F83-A2A7-1432D4430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568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90C72A-187C-6895-575F-48875C2952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A92AED-20E8-820D-A7FB-BDF95A2471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DB84AD-57A8-BCB5-8326-9BB825D95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16F91A-09E4-1B3C-3322-FD335877B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805518-1705-3004-E17D-B1DD25558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053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962DC-8FF9-B45C-6AF5-69120A6A0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08A9B03-7507-2D87-8C72-D3FCF643B8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BB20D2-3A8B-6C0A-E934-B146F11171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87B7B6-6523-85AF-27FD-1F202414F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4FD4BB-BC17-7759-E263-D4745D1C8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4FB9694-472B-9660-ED1E-1501DB97D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3768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C9AA7D-65E8-5C49-066E-E7696859C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1BAAD3-FCD7-8134-4E42-0421BF2768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394D46C-0D14-B69E-B344-B8EF376BCA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76B210E-5D3E-A8B7-7577-7F4C683F0C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477BE13-14C0-D2F8-7423-1A466CDE6B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17A7606-092A-59BF-CD6C-E32DDC934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2149781-58CD-0A09-DD5D-AE531546E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2DC7A03-E28D-23D4-B692-56A43F35C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7764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42C983-5B81-BA41-5DAC-215A6A390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D943624-9F48-3161-706D-9ADC21B54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C3EB2D3-CEE8-4595-4D3A-029D005CB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BEBC5EC-8E31-1BDA-C001-6AA0DC114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8185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ADF2C6D-61D6-1645-0D28-EAC5269C0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85318DF-131F-DEA1-6F07-ED78660FD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11D7FF0-137F-C2B5-B78F-222DA9193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0380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854564-7B29-1498-EB27-829B55F0D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63023D-B867-0E65-E75F-796CA77F91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654904B-901E-4BFD-5CD6-9398CB69BF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418E202-078A-623A-AD20-E3DE0F8C2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44472D-193B-FD4C-97DA-219FF4CD1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2DC8C7-505C-B2BE-5855-D4F8C9985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374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C985C1-02A2-354E-F3B6-CF4001496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39E404D-6252-E55D-E360-104EC2B1FD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2CD2DB6-122D-DA20-9C09-B3F1B63BA8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A962440-F95A-8CA4-D423-8A39A06A4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9EB608F-ED13-7298-28EF-567E79D82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EA7CC1F-CABC-FF36-902E-85918B5A2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6161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9DBEED5-D50F-7474-D898-3F0402EF3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9D833CE-F32E-99DC-8506-5FB3D7E358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B0EFFE-9046-4337-5026-875D0DF940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C6AF11-7284-4CDE-AD9B-1EAB25702D93}" type="datetimeFigureOut">
              <a:rPr lang="zh-CN" altLang="en-US" smtClean="0"/>
              <a:t>2022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F4FFD4-9653-04E2-E7A9-004E718B03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3662AF-F048-ABE8-07C3-230870242C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240B4-DF7A-4E8D-B31C-F4FC460B98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895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9AFE5A58-841F-6803-0D09-923AA394C7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9179171" cy="6858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040FEC4-4197-575C-A51E-D3C767D477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30567" y="471298"/>
            <a:ext cx="3614764" cy="98108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F27FB3A1-CCE8-DA56-761A-685E4C0C2681}"/>
              </a:ext>
            </a:extLst>
          </p:cNvPr>
          <p:cNvSpPr/>
          <p:nvPr/>
        </p:nvSpPr>
        <p:spPr>
          <a:xfrm rot="344283">
            <a:off x="3418425" y="3027271"/>
            <a:ext cx="2805405" cy="407610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B1F313F-6570-306F-F820-8115641011E5}"/>
              </a:ext>
            </a:extLst>
          </p:cNvPr>
          <p:cNvSpPr txBox="1"/>
          <p:nvPr/>
        </p:nvSpPr>
        <p:spPr>
          <a:xfrm>
            <a:off x="9368970" y="1506063"/>
            <a:ext cx="2743202" cy="17098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3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-i  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racterization of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sCA1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lines by Western blotting.</a:t>
            </a:r>
            <a:endParaRPr lang="zh-CN" altLang="zh-CN" sz="28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FAA5BB8-60DB-446F-A36D-A67712B7C607}"/>
              </a:ext>
            </a:extLst>
          </p:cNvPr>
          <p:cNvSpPr txBox="1"/>
          <p:nvPr/>
        </p:nvSpPr>
        <p:spPr>
          <a:xfrm>
            <a:off x="5232397" y="4640440"/>
            <a:ext cx="32366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gion for western blot analysis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4638341D-D312-FEE5-7440-C16F8858142B}"/>
              </a:ext>
            </a:extLst>
          </p:cNvPr>
          <p:cNvCxnSpPr>
            <a:cxnSpLocks/>
          </p:cNvCxnSpPr>
          <p:nvPr/>
        </p:nvCxnSpPr>
        <p:spPr>
          <a:xfrm flipH="1" flipV="1">
            <a:off x="4586514" y="3483429"/>
            <a:ext cx="1023257" cy="1153885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6921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408F1795-6119-06A7-A756-B54525E44E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9179171" cy="6858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412ADA9-45A7-32D5-2FD0-CE309BFD43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1222" y="598284"/>
            <a:ext cx="4800635" cy="947744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289CF2D1-91CE-2396-F9CD-BF1A41043B25}"/>
              </a:ext>
            </a:extLst>
          </p:cNvPr>
          <p:cNvSpPr/>
          <p:nvPr/>
        </p:nvSpPr>
        <p:spPr>
          <a:xfrm>
            <a:off x="1971869" y="3253272"/>
            <a:ext cx="4005943" cy="32346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B0A7E9E-0772-6AC9-A0D4-84F38750D428}"/>
              </a:ext>
            </a:extLst>
          </p:cNvPr>
          <p:cNvSpPr txBox="1"/>
          <p:nvPr/>
        </p:nvSpPr>
        <p:spPr>
          <a:xfrm>
            <a:off x="9368970" y="1506063"/>
            <a:ext cx="2743202" cy="17098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3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-ii  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racterization of </a:t>
            </a:r>
            <a:r>
              <a:rPr lang="en-US" altLang="zh-CN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sCA4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lines by Western blotting.</a:t>
            </a:r>
            <a:endParaRPr lang="zh-CN" altLang="zh-CN" sz="28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7113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48">
            <a:extLst>
              <a:ext uri="{FF2B5EF4-FFF2-40B4-BE49-F238E27FC236}">
                <a16:creationId xmlns:a16="http://schemas.microsoft.com/office/drawing/2014/main" id="{28BA67C6-62D0-9CAF-B87B-2EA326DEE3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8" y="-5387"/>
            <a:ext cx="9186381" cy="686338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33E88597-4919-9BEF-592A-E940FB00FC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1725" y="563081"/>
            <a:ext cx="3605239" cy="942982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95CDEF88-B130-BFF4-4503-FA752E0C382E}"/>
              </a:ext>
            </a:extLst>
          </p:cNvPr>
          <p:cNvSpPr txBox="1"/>
          <p:nvPr/>
        </p:nvSpPr>
        <p:spPr>
          <a:xfrm>
            <a:off x="9368970" y="1506063"/>
            <a:ext cx="2743202" cy="17098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3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-iii  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racterization of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4SF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lines by Western blotting.</a:t>
            </a:r>
            <a:endParaRPr lang="zh-CN" altLang="zh-CN" sz="28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C39EBF3-BF13-F104-3D5B-8844E70E3FAF}"/>
              </a:ext>
            </a:extLst>
          </p:cNvPr>
          <p:cNvSpPr txBox="1"/>
          <p:nvPr/>
        </p:nvSpPr>
        <p:spPr>
          <a:xfrm>
            <a:off x="5798454" y="1447027"/>
            <a:ext cx="32366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gion for western blot analysis</a:t>
            </a:r>
            <a:endParaRPr lang="zh-CN" altLang="en-US" dirty="0"/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510FE09A-8B51-3565-9947-AC4F9CE1F1C3}"/>
              </a:ext>
            </a:extLst>
          </p:cNvPr>
          <p:cNvCxnSpPr>
            <a:cxnSpLocks/>
          </p:cNvCxnSpPr>
          <p:nvPr/>
        </p:nvCxnSpPr>
        <p:spPr>
          <a:xfrm flipH="1">
            <a:off x="4528457" y="1816359"/>
            <a:ext cx="1788885" cy="121920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矩形 45">
            <a:extLst>
              <a:ext uri="{FF2B5EF4-FFF2-40B4-BE49-F238E27FC236}">
                <a16:creationId xmlns:a16="http://schemas.microsoft.com/office/drawing/2014/main" id="{0EEA32FE-64FB-D12C-E595-31A3143717EC}"/>
              </a:ext>
            </a:extLst>
          </p:cNvPr>
          <p:cNvSpPr/>
          <p:nvPr/>
        </p:nvSpPr>
        <p:spPr>
          <a:xfrm rot="21343423">
            <a:off x="2157252" y="3122133"/>
            <a:ext cx="2729736" cy="392204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9853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A3A0E250-7DFA-4F0E-6D56-F5B0B30AE5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249940" cy="691087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3E47109-BB0B-4A95-F70D-904F7AF6CE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9667" y="511272"/>
            <a:ext cx="5655298" cy="919169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3010DB3C-C6BC-A015-B850-09644337F5FE}"/>
              </a:ext>
            </a:extLst>
          </p:cNvPr>
          <p:cNvSpPr/>
          <p:nvPr/>
        </p:nvSpPr>
        <p:spPr>
          <a:xfrm>
            <a:off x="2282890" y="2673350"/>
            <a:ext cx="4410269" cy="362209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36952D2-6E93-C183-6538-3B1B31A9F0C7}"/>
              </a:ext>
            </a:extLst>
          </p:cNvPr>
          <p:cNvSpPr txBox="1"/>
          <p:nvPr/>
        </p:nvSpPr>
        <p:spPr>
          <a:xfrm>
            <a:off x="9368970" y="1506063"/>
            <a:ext cx="2743202" cy="17098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3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-iv  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racterization of </a:t>
            </a:r>
            <a:r>
              <a:rPr lang="en-US" altLang="zh-CN" i="1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sSBP</a:t>
            </a:r>
            <a:r>
              <a:rPr lang="en-US" altLang="zh-CN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genic lines by Western blotting.</a:t>
            </a:r>
            <a:endParaRPr lang="zh-CN" altLang="zh-CN" sz="28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0292CBD-9EAA-67CB-5D21-D3564BC2685F}"/>
              </a:ext>
            </a:extLst>
          </p:cNvPr>
          <p:cNvSpPr txBox="1"/>
          <p:nvPr/>
        </p:nvSpPr>
        <p:spPr>
          <a:xfrm>
            <a:off x="5137959" y="4657806"/>
            <a:ext cx="32366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gion for western blot analysis</a:t>
            </a:r>
            <a:endParaRPr lang="zh-CN" altLang="en-US" dirty="0"/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AA4A769D-21F7-FE20-2910-946445BDA59B}"/>
              </a:ext>
            </a:extLst>
          </p:cNvPr>
          <p:cNvCxnSpPr>
            <a:cxnSpLocks/>
          </p:cNvCxnSpPr>
          <p:nvPr/>
        </p:nvCxnSpPr>
        <p:spPr>
          <a:xfrm flipH="1" flipV="1">
            <a:off x="4499333" y="3094595"/>
            <a:ext cx="1509582" cy="1688841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09326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77264D4F-36D2-1F8A-74AB-C9680763F3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-1" y="0"/>
            <a:ext cx="9249940" cy="6858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053BA5C-0CCC-F0DA-4C58-807CB64670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5062" y="422701"/>
            <a:ext cx="5467390" cy="933457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D8293FE-44D9-4A2E-B2B2-0F6CE33E2432}"/>
              </a:ext>
            </a:extLst>
          </p:cNvPr>
          <p:cNvSpPr txBox="1"/>
          <p:nvPr/>
        </p:nvSpPr>
        <p:spPr>
          <a:xfrm>
            <a:off x="9368970" y="1506063"/>
            <a:ext cx="2743202" cy="17098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3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-v  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racterization of </a:t>
            </a:r>
            <a:r>
              <a:rPr lang="en-US" altLang="zh-CN" i="1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sFBA</a:t>
            </a:r>
            <a:r>
              <a:rPr lang="en-US" altLang="zh-CN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genic lines by Western blotting.</a:t>
            </a:r>
            <a:endParaRPr lang="zh-CN" altLang="zh-CN" sz="28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50EC2468-A738-23BA-BA8D-18DBC6AC4574}"/>
              </a:ext>
            </a:extLst>
          </p:cNvPr>
          <p:cNvSpPr/>
          <p:nvPr/>
        </p:nvSpPr>
        <p:spPr>
          <a:xfrm rot="21040352">
            <a:off x="2711742" y="3202653"/>
            <a:ext cx="3724258" cy="249661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AF3E55A-0469-4498-3E95-00A89910FF9F}"/>
              </a:ext>
            </a:extLst>
          </p:cNvPr>
          <p:cNvSpPr txBox="1"/>
          <p:nvPr/>
        </p:nvSpPr>
        <p:spPr>
          <a:xfrm>
            <a:off x="4963787" y="5100492"/>
            <a:ext cx="32366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gion for western blot analysis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C76E9F50-8774-3D7F-8F53-A54E2033E6CD}"/>
              </a:ext>
            </a:extLst>
          </p:cNvPr>
          <p:cNvCxnSpPr>
            <a:cxnSpLocks/>
          </p:cNvCxnSpPr>
          <p:nvPr/>
        </p:nvCxnSpPr>
        <p:spPr>
          <a:xfrm flipH="1" flipV="1">
            <a:off x="4325161" y="3537281"/>
            <a:ext cx="1509582" cy="1688841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33176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70</Words>
  <Application>Microsoft Office PowerPoint</Application>
  <PresentationFormat>宽屏</PresentationFormat>
  <Paragraphs>9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志峰</dc:creator>
  <cp:lastModifiedBy>陈 志峰</cp:lastModifiedBy>
  <cp:revision>1</cp:revision>
  <dcterms:created xsi:type="dcterms:W3CDTF">2022-09-19T01:36:21Z</dcterms:created>
  <dcterms:modified xsi:type="dcterms:W3CDTF">2022-09-19T02:33:10Z</dcterms:modified>
</cp:coreProperties>
</file>